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57120" y="718920"/>
            <a:ext cx="4802040" cy="3601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4E6635-5FEE-4CF6-95EA-5C17A4B128A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2040" cy="360180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2EA2DA-856A-4292-8E0C-6ECC07E0F47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E0627-3FC6-4CE7-9CCA-DFAECF8330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288A7-4F2A-4FF6-ADB8-7E115BAD0A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09BF8-2AF7-4B1D-91E3-6F76EE3550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64DC8-F9AB-4B27-983C-715ED2BD68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31C86-0E97-4D4F-9922-3AF4B5C9D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121014-C837-4D07-95AE-5A1513BD2F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4F284-E2DC-4D49-B554-B62823FD5C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B54E0-E218-4321-B428-F7FB0A4206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CE0D1-D614-4FEB-8B56-B569286D6A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899C3-AA16-4E95-BFCA-0B7171805F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9F862-28EF-4D9B-BA7F-E59ADF033C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33614-37A7-4D3E-AFB6-90A50F3907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6A05D4-F6E7-47C4-A2C7-76DF482DF0B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Diagram 41" descr=""/>
          <p:cNvPicPr/>
          <p:nvPr/>
        </p:nvPicPr>
        <p:blipFill>
          <a:blip r:embed="rId1"/>
          <a:stretch/>
        </p:blipFill>
        <p:spPr>
          <a:xfrm>
            <a:off x="3267000" y="4956120"/>
            <a:ext cx="5724720" cy="2462400"/>
          </a:xfrm>
          <a:prstGeom prst="rect">
            <a:avLst/>
          </a:prstGeom>
          <a:ln w="0">
            <a:noFill/>
          </a:ln>
        </p:spPr>
      </p:pic>
      <p:grpSp>
        <p:nvGrpSpPr>
          <p:cNvPr id="49" name="Group 4"/>
          <p:cNvGrpSpPr/>
          <p:nvPr/>
        </p:nvGrpSpPr>
        <p:grpSpPr>
          <a:xfrm>
            <a:off x="287280" y="419040"/>
            <a:ext cx="8610120" cy="5562720"/>
            <a:chOff x="287280" y="419040"/>
            <a:chExt cx="8610120" cy="5562720"/>
          </a:xfrm>
        </p:grpSpPr>
        <p:sp>
          <p:nvSpPr>
            <p:cNvPr id="50" name="Text Box 5"/>
            <p:cNvSpPr/>
            <p:nvPr/>
          </p:nvSpPr>
          <p:spPr>
            <a:xfrm>
              <a:off x="6535800" y="1333080"/>
              <a:ext cx="1158480" cy="1371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dividual &amp; Collective Capa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upportive environme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nhanced  ability to prevent and respond to VAW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Group 7"/>
            <p:cNvGrpSpPr/>
            <p:nvPr/>
          </p:nvGrpSpPr>
          <p:grpSpPr>
            <a:xfrm>
              <a:off x="287280" y="419040"/>
              <a:ext cx="8610120" cy="5562720"/>
              <a:chOff x="287280" y="419040"/>
              <a:chExt cx="8610120" cy="5562720"/>
            </a:xfrm>
          </p:grpSpPr>
          <p:sp>
            <p:nvSpPr>
              <p:cNvPr id="52" name="Text Box 8"/>
              <p:cNvSpPr/>
              <p:nvPr/>
            </p:nvSpPr>
            <p:spPr>
              <a:xfrm>
                <a:off x="6527520" y="4221720"/>
                <a:ext cx="1174320" cy="1447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stained A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hanged policie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Organized group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hanged practice in relationships, community, institution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9"/>
              <p:cNvSpPr/>
              <p:nvPr/>
            </p:nvSpPr>
            <p:spPr>
              <a:xfrm>
                <a:off x="603720" y="419040"/>
                <a:ext cx="7400160" cy="440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SASA! Logic Model 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10"/>
              <p:cNvSpPr/>
              <p:nvPr/>
            </p:nvSpPr>
            <p:spPr>
              <a:xfrm>
                <a:off x="4859280" y="2552400"/>
                <a:ext cx="1546560" cy="1295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A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Intention to ac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ersonal change: balancing power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ublic change: sanctions against VAW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Acceptability of expanded gender role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1"/>
              <p:cNvSpPr/>
              <p:nvPr/>
            </p:nvSpPr>
            <p:spPr>
              <a:xfrm>
                <a:off x="6527520" y="2772360"/>
                <a:ext cx="1174320" cy="129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Behavio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Balancing power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mmunication with partner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Decreased risk behavio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mmunity activis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13"/>
              <p:cNvSpPr/>
              <p:nvPr/>
            </p:nvSpPr>
            <p:spPr>
              <a:xfrm>
                <a:off x="4908240" y="3924360"/>
                <a:ext cx="1487160" cy="9140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Acceptance and Influenc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Attitudes toward power, gender, human right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ilence broke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4"/>
              <p:cNvSpPr/>
              <p:nvPr/>
            </p:nvSpPr>
            <p:spPr>
              <a:xfrm>
                <a:off x="4917960" y="4945680"/>
                <a:ext cx="1477800" cy="79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ne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Activists/leaders/professionals increasingly connected and activ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5"/>
              <p:cNvSpPr/>
              <p:nvPr/>
            </p:nvSpPr>
            <p:spPr>
              <a:xfrm>
                <a:off x="4859280" y="1333080"/>
                <a:ext cx="1561680" cy="11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ki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Response to women experiencing violenc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Hold men accountabl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romote balanced power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upport activists/ couple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AutoShape 16"/>
              <p:cNvSpPr/>
              <p:nvPr/>
            </p:nvSpPr>
            <p:spPr>
              <a:xfrm rot="5400000">
                <a:off x="750960" y="2878560"/>
                <a:ext cx="3084120" cy="2112120"/>
              </a:xfrm>
              <a:prstGeom prst="triangle">
                <a:avLst>
                  <a:gd name="adj" fmla="val 42028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 Box 17"/>
              <p:cNvSpPr/>
              <p:nvPr/>
            </p:nvSpPr>
            <p:spPr>
              <a:xfrm>
                <a:off x="287280" y="875880"/>
                <a:ext cx="1183680" cy="382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Contex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Oval 18"/>
              <p:cNvSpPr/>
              <p:nvPr/>
            </p:nvSpPr>
            <p:spPr>
              <a:xfrm>
                <a:off x="1392120" y="1601640"/>
                <a:ext cx="1447920" cy="11505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ocieta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at’l policy makers, medi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Oval 19"/>
              <p:cNvSpPr/>
              <p:nvPr/>
            </p:nvSpPr>
            <p:spPr>
              <a:xfrm>
                <a:off x="1353600" y="2406960"/>
                <a:ext cx="1524240" cy="13485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mmunit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lice, Local Leaders, Health Care Providers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,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senga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Oval 20"/>
              <p:cNvSpPr/>
              <p:nvPr/>
            </p:nvSpPr>
            <p:spPr>
              <a:xfrm>
                <a:off x="1353600" y="3467160"/>
                <a:ext cx="1599840" cy="1143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86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Relationshi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latives, elders, friends, neighbo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 Box 21"/>
              <p:cNvSpPr/>
              <p:nvPr/>
            </p:nvSpPr>
            <p:spPr>
              <a:xfrm>
                <a:off x="1587240" y="723960"/>
                <a:ext cx="1311120" cy="762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Levels of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ASA! Activities reaching each Circle of Influence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 Box 22"/>
              <p:cNvSpPr/>
              <p:nvPr/>
            </p:nvSpPr>
            <p:spPr>
              <a:xfrm>
                <a:off x="2954520" y="875880"/>
                <a:ext cx="1817280" cy="511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nitial Outcome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 Box 23"/>
              <p:cNvSpPr/>
              <p:nvPr/>
            </p:nvSpPr>
            <p:spPr>
              <a:xfrm>
                <a:off x="2898720" y="1333080"/>
                <a:ext cx="1873080" cy="11019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Knowledg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Recognizing VAW as proble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Types of VAW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nsequences of VAW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VAW/HIV linkag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Text Box 24"/>
              <p:cNvSpPr/>
              <p:nvPr/>
            </p:nvSpPr>
            <p:spPr>
              <a:xfrm>
                <a:off x="2968200" y="2629080"/>
                <a:ext cx="1817640" cy="10764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Awarenes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Root cause as imbalance of power between women and me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hange can happe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 Box 25"/>
              <p:cNvSpPr/>
              <p:nvPr/>
            </p:nvSpPr>
            <p:spPr>
              <a:xfrm>
                <a:off x="3029040" y="4975200"/>
                <a:ext cx="1800000" cy="701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articipa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Activists at grassroots, in leadership, in institution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 Box 26"/>
              <p:cNvSpPr/>
              <p:nvPr/>
            </p:nvSpPr>
            <p:spPr>
              <a:xfrm>
                <a:off x="4935240" y="875880"/>
                <a:ext cx="1617480" cy="384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ntermediate Outcome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Oval 27"/>
              <p:cNvSpPr/>
              <p:nvPr/>
            </p:nvSpPr>
            <p:spPr>
              <a:xfrm>
                <a:off x="1353600" y="4524840"/>
                <a:ext cx="1614240" cy="1305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86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ndividua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Women, men, youth, community activis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 Box 28"/>
              <p:cNvSpPr/>
              <p:nvPr/>
            </p:nvSpPr>
            <p:spPr>
              <a:xfrm>
                <a:off x="6459480" y="799920"/>
                <a:ext cx="1311120" cy="5108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Longer term outcome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 Box 29"/>
              <p:cNvSpPr/>
              <p:nvPr/>
            </p:nvSpPr>
            <p:spPr>
              <a:xfrm>
                <a:off x="7825320" y="799920"/>
                <a:ext cx="1055160" cy="384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mpac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30"/>
              <p:cNvSpPr/>
              <p:nvPr/>
            </p:nvSpPr>
            <p:spPr>
              <a:xfrm>
                <a:off x="287280" y="1333080"/>
                <a:ext cx="1066320" cy="46486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ocio-demographic Facto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ex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g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Incom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Educ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Employme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lig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lace of residence / levels of mobilit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ocio-cultural Facto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amily Characteristic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ocial Suppo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lcohol Us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 Box 31"/>
              <p:cNvSpPr/>
              <p:nvPr/>
            </p:nvSpPr>
            <p:spPr>
              <a:xfrm>
                <a:off x="7831080" y="1333080"/>
                <a:ext cx="1066320" cy="4156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Reduced social acceptance of gender inequality and IP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ecrease in experience / perpetration of IP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mproved response to women experiencing violenc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ecrease in HIV/SRH risk behavior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AutoShape 32"/>
              <p:cNvSpPr/>
              <p:nvPr/>
            </p:nvSpPr>
            <p:spPr>
              <a:xfrm rot="5400000">
                <a:off x="4628160" y="1794960"/>
                <a:ext cx="41508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AutoShape 33"/>
              <p:cNvSpPr/>
              <p:nvPr/>
            </p:nvSpPr>
            <p:spPr>
              <a:xfrm rot="5400000">
                <a:off x="4677120" y="5265360"/>
                <a:ext cx="41580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AutoShape 34"/>
              <p:cNvSpPr/>
              <p:nvPr/>
            </p:nvSpPr>
            <p:spPr>
              <a:xfrm rot="5400000">
                <a:off x="4625640" y="4277160"/>
                <a:ext cx="41580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AutoShape 35"/>
              <p:cNvSpPr/>
              <p:nvPr/>
            </p:nvSpPr>
            <p:spPr>
              <a:xfrm rot="5400000">
                <a:off x="4625640" y="3014640"/>
                <a:ext cx="41580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AutoShape 36"/>
              <p:cNvSpPr/>
              <p:nvPr/>
            </p:nvSpPr>
            <p:spPr>
              <a:xfrm rot="5400000">
                <a:off x="6184440" y="4363560"/>
                <a:ext cx="52416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AutoShape 37"/>
              <p:cNvSpPr/>
              <p:nvPr/>
            </p:nvSpPr>
            <p:spPr>
              <a:xfrm rot="5400000">
                <a:off x="6206760" y="3225960"/>
                <a:ext cx="491760" cy="954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39"/>
              <p:cNvSpPr/>
              <p:nvPr/>
            </p:nvSpPr>
            <p:spPr>
              <a:xfrm>
                <a:off x="2954520" y="3848400"/>
                <a:ext cx="1815840" cy="955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ritical Thinking and Dialogu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ublic debate and discussion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Arial"/>
                  <a:buChar char="•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ersonal reflectio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AutoShape 40"/>
              <p:cNvSpPr/>
              <p:nvPr/>
            </p:nvSpPr>
            <p:spPr>
              <a:xfrm rot="5400000">
                <a:off x="6238440" y="5224320"/>
                <a:ext cx="415800" cy="10080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3" name="TextBox 37"/>
          <p:cNvSpPr/>
          <p:nvPr/>
        </p:nvSpPr>
        <p:spPr>
          <a:xfrm>
            <a:off x="3048120" y="6595920"/>
            <a:ext cx="5943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ASA! Phases / Process of Chang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Up-Down Arrow 38"/>
          <p:cNvSpPr/>
          <p:nvPr/>
        </p:nvSpPr>
        <p:spPr>
          <a:xfrm>
            <a:off x="3809880" y="2362320"/>
            <a:ext cx="152640" cy="304560"/>
          </a:xfrm>
          <a:prstGeom prst="upDownArrow">
            <a:avLst>
              <a:gd name="adj1" fmla="val 50000"/>
              <a:gd name="adj2" fmla="val 49882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Up-Down Arrow 39"/>
          <p:cNvSpPr/>
          <p:nvPr/>
        </p:nvSpPr>
        <p:spPr>
          <a:xfrm>
            <a:off x="3809880" y="3581280"/>
            <a:ext cx="152640" cy="304920"/>
          </a:xfrm>
          <a:prstGeom prst="upDownArrow">
            <a:avLst>
              <a:gd name="adj1" fmla="val 50000"/>
              <a:gd name="adj2" fmla="val 49941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Up-Down Arrow 40"/>
          <p:cNvSpPr/>
          <p:nvPr/>
        </p:nvSpPr>
        <p:spPr>
          <a:xfrm>
            <a:off x="3832200" y="4724280"/>
            <a:ext cx="152280" cy="304920"/>
          </a:xfrm>
          <a:prstGeom prst="upDownArrow">
            <a:avLst>
              <a:gd name="adj1" fmla="val 50000"/>
              <a:gd name="adj2" fmla="val 50059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Up-Down Arrow 42"/>
          <p:cNvSpPr/>
          <p:nvPr/>
        </p:nvSpPr>
        <p:spPr>
          <a:xfrm>
            <a:off x="5562720" y="2514600"/>
            <a:ext cx="75960" cy="152280"/>
          </a:xfrm>
          <a:prstGeom prst="upDownArrow">
            <a:avLst>
              <a:gd name="adj1" fmla="val 50000"/>
              <a:gd name="adj2" fmla="val 50118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Up-Down Arrow 43"/>
          <p:cNvSpPr/>
          <p:nvPr/>
        </p:nvSpPr>
        <p:spPr>
          <a:xfrm>
            <a:off x="5562720" y="3886200"/>
            <a:ext cx="75960" cy="152280"/>
          </a:xfrm>
          <a:prstGeom prst="upDownArrow">
            <a:avLst>
              <a:gd name="adj1" fmla="val 50000"/>
              <a:gd name="adj2" fmla="val 50118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Up-Down Arrow 44"/>
          <p:cNvSpPr/>
          <p:nvPr/>
        </p:nvSpPr>
        <p:spPr>
          <a:xfrm>
            <a:off x="5562720" y="4876920"/>
            <a:ext cx="75960" cy="152280"/>
          </a:xfrm>
          <a:prstGeom prst="upDownArrow">
            <a:avLst>
              <a:gd name="adj1" fmla="val 50000"/>
              <a:gd name="adj2" fmla="val 50118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Up-Down Arrow 45"/>
          <p:cNvSpPr/>
          <p:nvPr/>
        </p:nvSpPr>
        <p:spPr>
          <a:xfrm>
            <a:off x="7010280" y="2743200"/>
            <a:ext cx="76320" cy="152280"/>
          </a:xfrm>
          <a:prstGeom prst="upDownArrow">
            <a:avLst>
              <a:gd name="adj1" fmla="val 50000"/>
              <a:gd name="adj2" fmla="val 49882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Up-Down Arrow 46"/>
          <p:cNvSpPr/>
          <p:nvPr/>
        </p:nvSpPr>
        <p:spPr>
          <a:xfrm>
            <a:off x="7010280" y="4114800"/>
            <a:ext cx="76320" cy="152280"/>
          </a:xfrm>
          <a:prstGeom prst="upDownArrow">
            <a:avLst>
              <a:gd name="adj1" fmla="val 50000"/>
              <a:gd name="adj2" fmla="val 49882"/>
            </a:avLst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AutoShape 32"/>
          <p:cNvSpPr/>
          <p:nvPr/>
        </p:nvSpPr>
        <p:spPr>
          <a:xfrm rot="5400000">
            <a:off x="6265800" y="1909800"/>
            <a:ext cx="416160" cy="101520"/>
          </a:xfrm>
          <a:prstGeom prst="triangle">
            <a:avLst>
              <a:gd name="adj" fmla="val 50000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3" name="Straight Arrow Connector 49"/>
          <p:cNvCxnSpPr/>
          <p:nvPr/>
        </p:nvCxnSpPr>
        <p:spPr>
          <a:xfrm>
            <a:off x="3048120" y="6629400"/>
            <a:ext cx="59443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4" name="AutoShape 36"/>
          <p:cNvSpPr/>
          <p:nvPr/>
        </p:nvSpPr>
        <p:spPr>
          <a:xfrm rot="5400000">
            <a:off x="7467480" y="1981080"/>
            <a:ext cx="609840" cy="152640"/>
          </a:xfrm>
          <a:prstGeom prst="triangle">
            <a:avLst>
              <a:gd name="adj" fmla="val 50000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36"/>
          <p:cNvSpPr/>
          <p:nvPr/>
        </p:nvSpPr>
        <p:spPr>
          <a:xfrm rot="5400000">
            <a:off x="7483320" y="3352680"/>
            <a:ext cx="609840" cy="152640"/>
          </a:xfrm>
          <a:prstGeom prst="triangle">
            <a:avLst>
              <a:gd name="adj" fmla="val 50000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36"/>
          <p:cNvSpPr/>
          <p:nvPr/>
        </p:nvSpPr>
        <p:spPr>
          <a:xfrm rot="5400000">
            <a:off x="7467480" y="4876560"/>
            <a:ext cx="609480" cy="152640"/>
          </a:xfrm>
          <a:prstGeom prst="triangle">
            <a:avLst>
              <a:gd name="adj" fmla="val 50000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30T20:21:57Z</dcterms:created>
  <dc:creator>mellsberg</dc:creator>
  <dc:description/>
  <dc:language>en-US</dc:language>
  <cp:lastModifiedBy>Lori Michau</cp:lastModifiedBy>
  <dcterms:modified xsi:type="dcterms:W3CDTF">2013-12-07T10:35:19Z</dcterms:modified>
  <cp:revision>25</cp:revision>
  <dc:subject/>
  <dc:title>Slide 1</dc:title>
</cp:coreProperties>
</file>